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67" autoAdjust="0"/>
    <p:restoredTop sz="94660"/>
  </p:normalViewPr>
  <p:slideViewPr>
    <p:cSldViewPr snapToGrid="0">
      <p:cViewPr varScale="1">
        <p:scale>
          <a:sx n="57" d="100"/>
          <a:sy n="57" d="100"/>
        </p:scale>
        <p:origin x="1842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A8014-2EBC-47CC-BA94-6ED4B29A0D5A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15B5A-352C-4FF4-862A-8028E0797E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4397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A8014-2EBC-47CC-BA94-6ED4B29A0D5A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15B5A-352C-4FF4-862A-8028E0797E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3575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A8014-2EBC-47CC-BA94-6ED4B29A0D5A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15B5A-352C-4FF4-862A-8028E0797E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78672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A8014-2EBC-47CC-BA94-6ED4B29A0D5A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15B5A-352C-4FF4-862A-8028E0797E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61789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A8014-2EBC-47CC-BA94-6ED4B29A0D5A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15B5A-352C-4FF4-862A-8028E0797E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332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A8014-2EBC-47CC-BA94-6ED4B29A0D5A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15B5A-352C-4FF4-862A-8028E0797E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57528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A8014-2EBC-47CC-BA94-6ED4B29A0D5A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15B5A-352C-4FF4-862A-8028E0797E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68829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A8014-2EBC-47CC-BA94-6ED4B29A0D5A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15B5A-352C-4FF4-862A-8028E0797E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48319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A8014-2EBC-47CC-BA94-6ED4B29A0D5A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15B5A-352C-4FF4-862A-8028E0797E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4386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A8014-2EBC-47CC-BA94-6ED4B29A0D5A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15B5A-352C-4FF4-862A-8028E0797E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37899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A8014-2EBC-47CC-BA94-6ED4B29A0D5A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15B5A-352C-4FF4-862A-8028E0797E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37318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6A8014-2EBC-47CC-BA94-6ED4B29A0D5A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715B5A-352C-4FF4-862A-8028E0797E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25316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png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-234" y="-3361"/>
            <a:ext cx="29919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Xie, et al; Supplementary Figure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40658675"/>
              </p:ext>
            </p:extLst>
          </p:nvPr>
        </p:nvGraphicFramePr>
        <p:xfrm>
          <a:off x="11644" y="2711006"/>
          <a:ext cx="6839120" cy="97036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52712"/>
                <a:gridCol w="485422"/>
                <a:gridCol w="519289"/>
                <a:gridCol w="1365955"/>
                <a:gridCol w="553156"/>
                <a:gridCol w="428978"/>
                <a:gridCol w="1145556"/>
                <a:gridCol w="544026"/>
                <a:gridCol w="544026"/>
              </a:tblGrid>
              <a:tr h="121699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-PROGRESSION </a:t>
                      </a:r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RVIVAL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-PROGRESSION </a:t>
                      </a:r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RVIVAL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-PROGRESSION </a:t>
                      </a:r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RVIVAL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1073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ous</a:t>
                      </a:r>
                      <a:r>
                        <a:rPr lang="en-US" sz="1000" u="none" strike="noStrike" baseline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ov.ca. </a:t>
                      </a:r>
                      <a:br>
                        <a:rPr lang="en-US" sz="1000" u="none" strike="noStrike" baseline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000" u="none" strike="noStrike" dirty="0" smtClean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tinum</a:t>
                      </a:r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reated n=70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ression of </a:t>
                      </a:r>
                      <a:r>
                        <a:rPr lang="en-US" sz="1000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</a:t>
                      </a:r>
                      <a:r>
                        <a:rPr lang="en-US" sz="1000" u="none" strike="noStrike" baseline="-25000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r>
                        <a:rPr lang="en-US" sz="1000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1</a:t>
                      </a:r>
                      <a:endParaRPr lang="en-US" sz="1000" b="0" i="0" u="none" strike="noStrike" dirty="0">
                        <a:solidFill>
                          <a:srgbClr val="0070C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ous</a:t>
                      </a:r>
                      <a:r>
                        <a:rPr lang="en-US" sz="1000" u="none" strike="noStrike" baseline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ov.ca. </a:t>
                      </a:r>
                      <a:br>
                        <a:rPr lang="en-US" sz="1000" u="none" strike="noStrike" baseline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000" u="none" strike="noStrike" dirty="0" smtClean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mcitabine</a:t>
                      </a:r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reated n=10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ression of </a:t>
                      </a:r>
                      <a:r>
                        <a:rPr lang="en-US" sz="1000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</a:t>
                      </a:r>
                      <a:r>
                        <a:rPr lang="en-US" sz="1000" u="none" strike="noStrike" baseline="-25000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r>
                        <a:rPr lang="en-US" sz="1000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1</a:t>
                      </a:r>
                      <a:endParaRPr lang="en-US" sz="1000" b="0" i="0" u="none" strike="noStrike" dirty="0">
                        <a:solidFill>
                          <a:srgbClr val="0070C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ous</a:t>
                      </a:r>
                      <a:r>
                        <a:rPr lang="en-US" sz="1000" u="none" strike="noStrike" baseline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ov.ca. </a:t>
                      </a:r>
                      <a:br>
                        <a:rPr lang="en-US" sz="1000" u="none" strike="noStrike" baseline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000" u="none" strike="noStrike" dirty="0" err="1" smtClean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potecan</a:t>
                      </a:r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reated n=10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ression of </a:t>
                      </a:r>
                      <a:r>
                        <a:rPr lang="en-US" sz="1000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</a:t>
                      </a:r>
                      <a:r>
                        <a:rPr lang="en-US" sz="1000" u="none" strike="noStrike" baseline="-25000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r>
                        <a:rPr lang="en-US" sz="1000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1</a:t>
                      </a:r>
                      <a:endParaRPr lang="en-US" sz="1000" b="0" i="0" u="none" strike="noStrike" dirty="0">
                        <a:solidFill>
                          <a:srgbClr val="0070C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055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</a:tr>
              <a:tr h="16609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of subject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of subject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of subject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</a:tr>
              <a:tr h="16609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PS, 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th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.1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.8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PS, 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th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.5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.5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PS, 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th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5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.4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  <p:grpSp>
        <p:nvGrpSpPr>
          <p:cNvPr id="7" name="Group 6"/>
          <p:cNvGrpSpPr/>
          <p:nvPr/>
        </p:nvGrpSpPr>
        <p:grpSpPr>
          <a:xfrm>
            <a:off x="-65438" y="582280"/>
            <a:ext cx="2363644" cy="2150609"/>
            <a:chOff x="149053" y="5757269"/>
            <a:chExt cx="2363644" cy="2150609"/>
          </a:xfrm>
        </p:grpSpPr>
        <p:sp>
          <p:nvSpPr>
            <p:cNvPr id="8" name="TextBox 7"/>
            <p:cNvSpPr txBox="1"/>
            <p:nvPr/>
          </p:nvSpPr>
          <p:spPr>
            <a:xfrm>
              <a:off x="277575" y="5757269"/>
              <a:ext cx="385666" cy="18174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23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  <a:p>
              <a:pPr>
                <a:lnSpc>
                  <a:spcPts val="23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</a:p>
            <a:p>
              <a:pPr>
                <a:lnSpc>
                  <a:spcPts val="23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</a:p>
            <a:p>
              <a:pPr>
                <a:lnSpc>
                  <a:spcPts val="23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</a:p>
            <a:p>
              <a:pPr>
                <a:lnSpc>
                  <a:spcPts val="23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</a:p>
            <a:p>
              <a:pPr>
                <a:lnSpc>
                  <a:spcPts val="23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9" name="Group 8"/>
            <p:cNvGrpSpPr/>
            <p:nvPr/>
          </p:nvGrpSpPr>
          <p:grpSpPr>
            <a:xfrm>
              <a:off x="149053" y="5821689"/>
              <a:ext cx="2363644" cy="2086189"/>
              <a:chOff x="3840523" y="5821689"/>
              <a:chExt cx="2363644" cy="2086189"/>
            </a:xfrm>
          </p:grpSpPr>
          <p:pic>
            <p:nvPicPr>
              <p:cNvPr id="10" name="Picture 9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787" t="11667" r="5879" b="21228"/>
              <a:stretch/>
            </p:blipFill>
            <p:spPr>
              <a:xfrm>
                <a:off x="4245306" y="5876649"/>
                <a:ext cx="1950345" cy="1662097"/>
              </a:xfrm>
              <a:prstGeom prst="rect">
                <a:avLst/>
              </a:prstGeom>
            </p:spPr>
          </p:pic>
          <p:sp>
            <p:nvSpPr>
              <p:cNvPr id="11" name="TextBox 10"/>
              <p:cNvSpPr txBox="1"/>
              <p:nvPr/>
            </p:nvSpPr>
            <p:spPr>
              <a:xfrm>
                <a:off x="4162828" y="7507768"/>
                <a:ext cx="2041339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         50       100       150      200   </a:t>
                </a:r>
              </a:p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      Time, months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 rot="16200000">
                <a:off x="3079644" y="6582568"/>
                <a:ext cx="176797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ost-Progression Survival 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5013504" y="6163897"/>
                <a:ext cx="471369" cy="10156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>
                  <a:lnSpc>
                    <a:spcPts val="2000"/>
                  </a:lnSpc>
                </a:pPr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  <a:p>
                <a:pPr algn="r">
                  <a:lnSpc>
                    <a:spcPts val="2000"/>
                  </a:lnSpc>
                </a:pPr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  <a:p>
                <a:pPr algn="r">
                  <a:lnSpc>
                    <a:spcPts val="2000"/>
                  </a:lnSpc>
                </a:pPr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  <a:p>
                <a:pPr algn="r"/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 rot="16200000">
                <a:off x="4725388" y="6403016"/>
                <a:ext cx="897978" cy="3488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lnSpc>
                    <a:spcPts val="1000"/>
                  </a:lnSpc>
                </a:pPr>
                <a:r>
                  <a:rPr lang="en-US" sz="1000" dirty="0" smtClean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X</a:t>
                </a:r>
                <a:r>
                  <a:rPr lang="en-US" sz="1000" baseline="-25000" dirty="0" smtClean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n-US" sz="1000" dirty="0" smtClean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R1</a:t>
                </a:r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expression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5100364" y="6054738"/>
                <a:ext cx="48069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×</a:t>
                </a:r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10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pic>
            <p:nvPicPr>
              <p:cNvPr id="16" name="Picture 15"/>
              <p:cNvPicPr>
                <a:picLocks noChangeAspect="1"/>
              </p:cNvPicPr>
              <p:nvPr/>
            </p:nvPicPr>
            <p:blipFill rotWithShape="1">
              <a:blip r:embed="rId3"/>
              <a:srcRect l="10309" t="11975" r="5740" b="15186"/>
              <a:stretch/>
            </p:blipFill>
            <p:spPr>
              <a:xfrm>
                <a:off x="5423335" y="6232748"/>
                <a:ext cx="767648" cy="666040"/>
              </a:xfrm>
              <a:prstGeom prst="rect">
                <a:avLst/>
              </a:prstGeom>
            </p:spPr>
          </p:pic>
        </p:grpSp>
      </p:grpSp>
      <p:grpSp>
        <p:nvGrpSpPr>
          <p:cNvPr id="17" name="Group 16"/>
          <p:cNvGrpSpPr/>
          <p:nvPr/>
        </p:nvGrpSpPr>
        <p:grpSpPr>
          <a:xfrm>
            <a:off x="2346292" y="584776"/>
            <a:ext cx="2335795" cy="2148113"/>
            <a:chOff x="6898516" y="5740334"/>
            <a:chExt cx="2335795" cy="2148113"/>
          </a:xfrm>
        </p:grpSpPr>
        <p:pic>
          <p:nvPicPr>
            <p:cNvPr id="18" name="Picture 17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528" t="11852" r="6064" b="21084"/>
            <a:stretch/>
          </p:blipFill>
          <p:spPr>
            <a:xfrm>
              <a:off x="7179732" y="5883117"/>
              <a:ext cx="1960679" cy="1635284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 rotWithShape="1">
            <a:blip r:embed="rId5"/>
            <a:srcRect l="10803" t="11728" r="5740" b="14692"/>
            <a:stretch/>
          </p:blipFill>
          <p:spPr>
            <a:xfrm>
              <a:off x="8378994" y="6229227"/>
              <a:ext cx="763131" cy="672816"/>
            </a:xfrm>
            <a:prstGeom prst="rect">
              <a:avLst/>
            </a:prstGeom>
          </p:spPr>
        </p:pic>
        <p:sp>
          <p:nvSpPr>
            <p:cNvPr id="20" name="TextBox 19"/>
            <p:cNvSpPr txBox="1"/>
            <p:nvPr/>
          </p:nvSpPr>
          <p:spPr>
            <a:xfrm rot="16200000">
              <a:off x="7678380" y="6383784"/>
              <a:ext cx="897978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000"/>
                </a:lnSpc>
              </a:pPr>
              <a:r>
                <a:rPr lang="en-US" sz="1000" dirty="0" smtClean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X</a:t>
              </a:r>
              <a:r>
                <a:rPr lang="en-US" sz="1000" baseline="-25000" dirty="0" smtClean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1000" dirty="0" smtClean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R1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expression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7973413" y="6162969"/>
              <a:ext cx="471369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20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  <a:p>
              <a:pPr algn="r">
                <a:lnSpc>
                  <a:spcPts val="20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  <a:p>
              <a:pPr algn="r">
                <a:lnSpc>
                  <a:spcPts val="20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  <a:p>
              <a:pPr algn="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8061095" y="6016916"/>
              <a:ext cx="4806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×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6898516" y="5740334"/>
              <a:ext cx="385666" cy="18174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23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  <a:p>
              <a:pPr>
                <a:lnSpc>
                  <a:spcPts val="23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</a:p>
            <a:p>
              <a:pPr>
                <a:lnSpc>
                  <a:spcPts val="23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</a:p>
            <a:p>
              <a:pPr>
                <a:lnSpc>
                  <a:spcPts val="23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</a:p>
            <a:p>
              <a:pPr>
                <a:lnSpc>
                  <a:spcPts val="23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</a:p>
            <a:p>
              <a:pPr>
                <a:lnSpc>
                  <a:spcPts val="23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7102084" y="7488337"/>
              <a:ext cx="213222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              50            100           150    </a:t>
              </a:r>
            </a:p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Time, month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5" name="TextBox 24"/>
          <p:cNvSpPr txBox="1"/>
          <p:nvPr/>
        </p:nvSpPr>
        <p:spPr>
          <a:xfrm>
            <a:off x="417688" y="527503"/>
            <a:ext cx="17657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TINUM</a:t>
            </a:r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TREATED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739102" y="534301"/>
            <a:ext cx="17657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MCITABINE</a:t>
            </a:r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TREATED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" name="Group 26"/>
          <p:cNvGrpSpPr/>
          <p:nvPr/>
        </p:nvGrpSpPr>
        <p:grpSpPr>
          <a:xfrm>
            <a:off x="4610036" y="432331"/>
            <a:ext cx="2324039" cy="2301199"/>
            <a:chOff x="4610036" y="5866967"/>
            <a:chExt cx="2324039" cy="2301199"/>
          </a:xfrm>
        </p:grpSpPr>
        <p:cxnSp>
          <p:nvCxnSpPr>
            <p:cNvPr id="28" name="Straight Connector 27"/>
            <p:cNvCxnSpPr/>
            <p:nvPr/>
          </p:nvCxnSpPr>
          <p:spPr>
            <a:xfrm>
              <a:off x="5784959" y="5866967"/>
              <a:ext cx="376518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9" name="Picture 28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550" t="11659" r="6121" b="20315"/>
            <a:stretch/>
          </p:blipFill>
          <p:spPr>
            <a:xfrm>
              <a:off x="4888585" y="6165620"/>
              <a:ext cx="1958755" cy="1658748"/>
            </a:xfrm>
            <a:prstGeom prst="rect">
              <a:avLst/>
            </a:prstGeom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 rotWithShape="1">
            <a:blip r:embed="rId7"/>
            <a:srcRect l="10185" t="11728" r="5739" b="14445"/>
            <a:stretch/>
          </p:blipFill>
          <p:spPr>
            <a:xfrm>
              <a:off x="6080110" y="6448727"/>
              <a:ext cx="768778" cy="675074"/>
            </a:xfrm>
            <a:prstGeom prst="rect">
              <a:avLst/>
            </a:prstGeom>
          </p:spPr>
        </p:pic>
        <p:sp>
          <p:nvSpPr>
            <p:cNvPr id="31" name="TextBox 30"/>
            <p:cNvSpPr txBox="1"/>
            <p:nvPr/>
          </p:nvSpPr>
          <p:spPr>
            <a:xfrm>
              <a:off x="4610036" y="6026667"/>
              <a:ext cx="385666" cy="18174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23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  <a:p>
              <a:pPr>
                <a:lnSpc>
                  <a:spcPts val="23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</a:p>
            <a:p>
              <a:pPr>
                <a:lnSpc>
                  <a:spcPts val="23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</a:p>
            <a:p>
              <a:pPr>
                <a:lnSpc>
                  <a:spcPts val="23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</a:p>
            <a:p>
              <a:pPr>
                <a:lnSpc>
                  <a:spcPts val="23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</a:p>
            <a:p>
              <a:pPr>
                <a:lnSpc>
                  <a:spcPts val="23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4801848" y="7768056"/>
              <a:ext cx="213222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      20     40      60     80    100    </a:t>
              </a:r>
            </a:p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Time, month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5013812" y="5985869"/>
              <a:ext cx="17657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i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POTECAN </a:t>
              </a:r>
              <a:r>
                <a:rPr lang="en-US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REATED</a:t>
              </a:r>
              <a:endParaRPr lang="en-US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5697318" y="6450723"/>
              <a:ext cx="471369" cy="9387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8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pPr algn="r">
                <a:lnSpc>
                  <a:spcPts val="18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  <a:p>
              <a:pPr algn="r">
                <a:lnSpc>
                  <a:spcPts val="18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  <a:p>
              <a:pPr algn="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 rot="16200000">
              <a:off x="5425199" y="6628505"/>
              <a:ext cx="897978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000"/>
                </a:lnSpc>
              </a:pPr>
              <a:r>
                <a:rPr lang="en-US" sz="1000" dirty="0" smtClean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X</a:t>
              </a:r>
              <a:r>
                <a:rPr lang="en-US" sz="1000" baseline="-25000" dirty="0" smtClean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1000" dirty="0" smtClean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R1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expression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5814466" y="6262084"/>
              <a:ext cx="4806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×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449567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3</TotalTime>
  <Words>142</Words>
  <Application>Microsoft Office PowerPoint</Application>
  <PresentationFormat>On-screen Show (4:3)</PresentationFormat>
  <Paragraphs>7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bolina, Maria</dc:creator>
  <cp:lastModifiedBy>Barbolina, Maria</cp:lastModifiedBy>
  <cp:revision>4</cp:revision>
  <cp:lastPrinted>2018-02-12T22:13:01Z</cp:lastPrinted>
  <dcterms:created xsi:type="dcterms:W3CDTF">2018-02-12T18:36:57Z</dcterms:created>
  <dcterms:modified xsi:type="dcterms:W3CDTF">2018-02-18T01:14:50Z</dcterms:modified>
</cp:coreProperties>
</file>